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avi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6" r:id="rId3"/>
    <p:sldId id="257" r:id="rId4"/>
    <p:sldId id="258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00"/>
    <a:srgbClr val="CC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9" d="100"/>
          <a:sy n="119" d="100"/>
        </p:scale>
        <p:origin x="-72" y="-3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3E840-EDCD-4B87-A0B3-1DFC6CBF79A8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800C-B8A6-4ADB-A1BD-EF27583853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6221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3E840-EDCD-4B87-A0B3-1DFC6CBF79A8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800C-B8A6-4ADB-A1BD-EF27583853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5485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3E840-EDCD-4B87-A0B3-1DFC6CBF79A8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800C-B8A6-4ADB-A1BD-EF27583853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29848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3E840-EDCD-4B87-A0B3-1DFC6CBF79A8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800C-B8A6-4ADB-A1BD-EF27583853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83038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3E840-EDCD-4B87-A0B3-1DFC6CBF79A8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800C-B8A6-4ADB-A1BD-EF27583853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86162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3E840-EDCD-4B87-A0B3-1DFC6CBF79A8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800C-B8A6-4ADB-A1BD-EF27583853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42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3E840-EDCD-4B87-A0B3-1DFC6CBF79A8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800C-B8A6-4ADB-A1BD-EF27583853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3570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3E840-EDCD-4B87-A0B3-1DFC6CBF79A8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800C-B8A6-4ADB-A1BD-EF27583853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6581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3E840-EDCD-4B87-A0B3-1DFC6CBF79A8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800C-B8A6-4ADB-A1BD-EF27583853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7010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3E840-EDCD-4B87-A0B3-1DFC6CBF79A8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800C-B8A6-4ADB-A1BD-EF27583853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7766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3E840-EDCD-4B87-A0B3-1DFC6CBF79A8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2800C-B8A6-4ADB-A1BD-EF27583853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4399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B3E840-EDCD-4B87-A0B3-1DFC6CBF79A8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52800C-B8A6-4ADB-A1BD-EF27583853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0028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avi"/><Relationship Id="rId1" Type="http://schemas.microsoft.com/office/2007/relationships/media" Target="../media/media2.avi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avi"/><Relationship Id="rId1" Type="http://schemas.microsoft.com/office/2007/relationships/media" Target="../media/media3.avi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9904" y="116632"/>
            <a:ext cx="863257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New </a:t>
            </a:r>
            <a:r>
              <a:rPr lang="en-CA" sz="16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Phytologist</a:t>
            </a:r>
            <a:r>
              <a:rPr lang="en-CA" sz="1600" b="1" dirty="0">
                <a:latin typeface="Arial" panose="020B0604020202020204" pitchFamily="34" charset="0"/>
                <a:cs typeface="Arial" panose="020B0604020202020204" pitchFamily="34" charset="0"/>
              </a:rPr>
              <a:t> Supporting Information 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Article title: 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Arabidopsis Lunapark proteins are involved in ER cisternae formation.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Authors: 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Verena Kriechbaumer, Emily Breeze, Charlotte Pain, Frances Tolmie, Lorenzo </a:t>
            </a:r>
            <a:r>
              <a:rPr lang="en-CA" sz="1600" dirty="0" err="1">
                <a:latin typeface="Arial" panose="020B0604020202020204" pitchFamily="34" charset="0"/>
                <a:cs typeface="Arial" panose="020B0604020202020204" pitchFamily="34" charset="0"/>
              </a:rPr>
              <a:t>Frigerio</a:t>
            </a:r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, Chris Hawes 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CA" sz="1600" dirty="0">
                <a:latin typeface="Arial" panose="020B0604020202020204" pitchFamily="34" charset="0"/>
                <a:cs typeface="Arial" panose="020B0604020202020204" pitchFamily="34" charset="0"/>
              </a:rPr>
              <a:t>Article acceptance date: 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17 April 2018</a:t>
            </a:r>
          </a:p>
        </p:txBody>
      </p:sp>
    </p:spTree>
    <p:extLst>
      <p:ext uri="{BB962C8B-B14F-4D97-AF65-F5344CB8AC3E}">
        <p14:creationId xmlns:p14="http://schemas.microsoft.com/office/powerpoint/2010/main" val="26624773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RFP-HDEL_0.05_OD_TS5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133600" y="1628800"/>
            <a:ext cx="4876800" cy="48768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150332" y="1253607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rgbClr val="CC00FF"/>
                </a:solidFill>
              </a:rPr>
              <a:t>RFP-HDEL</a:t>
            </a:r>
            <a:endParaRPr lang="en-GB" dirty="0">
              <a:solidFill>
                <a:srgbClr val="CC00FF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59904" y="116632"/>
            <a:ext cx="86325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7: </a:t>
            </a:r>
          </a:p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Example movies for ER network persistency analysis in Figure 10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273621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UbQ10-LNP1-GFP_0.05_OD+RFP-HDEL_0.05_TS6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133600" y="990600"/>
            <a:ext cx="4876800" cy="48768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124091" y="621268"/>
            <a:ext cx="4896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rgbClr val="CC00FF"/>
                </a:solidFill>
              </a:rPr>
              <a:t>RFP-HDEL </a:t>
            </a:r>
            <a:r>
              <a:rPr lang="en-GB" dirty="0" smtClean="0"/>
              <a:t>+ </a:t>
            </a:r>
            <a:r>
              <a:rPr lang="en-GB" dirty="0" smtClean="0">
                <a:solidFill>
                  <a:srgbClr val="00CC00"/>
                </a:solidFill>
              </a:rPr>
              <a:t>UbQ10::LNP1-GFP</a:t>
            </a:r>
            <a:endParaRPr lang="en-GB" dirty="0">
              <a:solidFill>
                <a:srgbClr val="00CC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1110301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133600" y="621268"/>
            <a:ext cx="487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rgbClr val="CC00FF"/>
                </a:solidFill>
              </a:rPr>
              <a:t>RFP-HDEL </a:t>
            </a:r>
            <a:r>
              <a:rPr lang="en-GB" dirty="0" smtClean="0"/>
              <a:t>+ </a:t>
            </a:r>
            <a:r>
              <a:rPr lang="en-GB" dirty="0" smtClean="0">
                <a:solidFill>
                  <a:srgbClr val="00CC00"/>
                </a:solidFill>
              </a:rPr>
              <a:t>GFP-</a:t>
            </a:r>
            <a:r>
              <a:rPr lang="en-GB" dirty="0" err="1" smtClean="0">
                <a:solidFill>
                  <a:srgbClr val="00CC00"/>
                </a:solidFill>
              </a:rPr>
              <a:t>Lifeact</a:t>
            </a:r>
            <a:r>
              <a:rPr lang="en-GB" dirty="0" smtClean="0">
                <a:solidFill>
                  <a:srgbClr val="00CC00"/>
                </a:solidFill>
              </a:rPr>
              <a:t> </a:t>
            </a:r>
            <a:r>
              <a:rPr lang="en-GB" dirty="0" smtClean="0"/>
              <a:t>+ Latrunculin B</a:t>
            </a:r>
            <a:endParaRPr lang="en-GB" dirty="0"/>
          </a:p>
        </p:txBody>
      </p:sp>
      <p:pic>
        <p:nvPicPr>
          <p:cNvPr id="5" name="GFP-Lifeact_0.03_OD+RFP_HDEL_0.05_OD+LatB_TS3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133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408951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43</Words>
  <Application>Microsoft Office PowerPoint</Application>
  <PresentationFormat>On-screen Show (4:3)</PresentationFormat>
  <Paragraphs>13</Paragraphs>
  <Slides>4</Slides>
  <Notes>0</Notes>
  <HiddenSlides>0</HiddenSlides>
  <MMClips>3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es Tolmie</dc:creator>
  <cp:lastModifiedBy>Verena Kriechbaumer</cp:lastModifiedBy>
  <cp:revision>5</cp:revision>
  <dcterms:created xsi:type="dcterms:W3CDTF">2018-04-05T09:08:31Z</dcterms:created>
  <dcterms:modified xsi:type="dcterms:W3CDTF">2018-04-18T14:39:47Z</dcterms:modified>
</cp:coreProperties>
</file>